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9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B94269-57AE-45A3-BB29-091229212EB9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7AF16A-9921-4DCB-90C8-D2FB31EEB17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292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 dirty="0"/>
              <a:t>サンプル数 生存期間中央値 </a:t>
            </a:r>
            <a:r>
              <a:rPr kumimoji="1" lang="en-US" altLang="ja-JP" dirty="0"/>
              <a:t>95%</a:t>
            </a:r>
            <a:r>
              <a:rPr kumimoji="1" lang="ja-JP" altLang="en-US" dirty="0"/>
              <a:t>信頼区間   </a:t>
            </a:r>
            <a:r>
              <a:rPr kumimoji="1" lang="en-US" altLang="ja-JP" dirty="0"/>
              <a:t>P</a:t>
            </a:r>
            <a:r>
              <a:rPr kumimoji="1" lang="ja-JP" altLang="en-US" dirty="0"/>
              <a:t>値</a:t>
            </a:r>
          </a:p>
          <a:p>
            <a:r>
              <a:rPr kumimoji="1" lang="en-US" altLang="ja-JP" dirty="0"/>
              <a:t>X..naïve.0..later.1..=0         21          205.0       84-NA 0.314</a:t>
            </a:r>
          </a:p>
          <a:p>
            <a:r>
              <a:rPr kumimoji="1" lang="en-US" altLang="ja-JP" dirty="0"/>
              <a:t>X..naïve.0..later.1..=1         16          108.5       60-NA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DC2557-6B53-41FF-A7AA-B80BC509971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0104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307B960-2D95-3472-69B4-5D470A6125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8B1919C-FFAD-E938-25EC-560D7DEB68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E8F879F-02DC-0B5E-F2F1-A0DE6EC89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5CCE040-AF50-D354-0C97-A3E6717E76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BC8E026-DD03-ABF8-4844-A4A364B4E4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55386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180B2A-A44C-6641-197F-469646DB82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8623293-4440-4C73-C61E-A90F60A42E4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02D450-9050-2E58-889F-9E8FAFD61E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BD6ABE1-5EB5-5C0A-47ED-8892058A12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D964084-40E0-8429-905A-D74B65C8C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5218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CD4F33F-54EC-D9CD-8528-015EF057128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2144FAF-6CC0-7BF7-8F1C-BB29ABA3A0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3DECC4B-16C8-5DB3-40D0-7DA5B28FAA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16BA392-B917-AD4D-28E6-35BD51CC4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1F44738-0871-17BE-1E97-D3F4BB82A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3874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DEC1CD3-9062-CC93-6D05-E0695468EE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E0DF9DA-A9A4-37CB-F5CF-18C7F644E7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8D5EB3-0A9D-F1E7-5865-E8966BA83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1DCEC0-D8FE-5BD3-BEDB-2CE0CEEE8F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49A2F0-ECDC-910C-43B0-E9DAB6976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6260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5BAB4A-C47D-6AD6-458A-6AC3D85D82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9F9C4A-81FD-6CDC-B1C1-03A3E18D78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5A6DF85-553F-93B8-107A-54B489ECF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D78876-A3CA-5529-1DD7-18C0CBBB51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5544FB-94DD-ECE9-9183-5EE536947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5195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38992C-5178-4D0C-4DA9-23CCB33A80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6794223-5D19-CCCB-83F5-20F0E65CCC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31B1912-CC8F-EE94-08FF-65D5A6236F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78B8082-B21E-F16D-E1C3-F63148E8D3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0857B51-C0E0-6CE9-1EBA-CD0DAC7A6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7B910C9-3B89-2ABE-4AF1-CBF4FA59F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270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0E6BFCA-6250-AF73-3586-FD206CD311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1B77CB2-40E4-0F7E-0205-DAB31D475E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FAF3217-0F02-2A03-06E2-128EC73FC5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2D34AC8-843E-7327-6338-0F7DD55E20E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8E40FBB-3670-02E0-9FD6-66884674DC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5E29A61-9319-3633-8C8D-3B5FC78CF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0736C7D-17DD-B8CE-99D5-B72BADB877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EEBD65E-820C-50CC-C4DA-F9FFD76A31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801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13F369-DF92-F8EE-D8E2-811D3385A9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FD53FB0-BBA7-6144-62AD-0A24B775B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2F83B8-9889-41DE-F82D-146E87E66C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F4FE36CB-ABA1-C180-24D9-F59E54003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5777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1B76B6A-A6FC-E721-FA27-245C97276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3A24CED-77AB-738B-B2DA-455187B68B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F25D946-0EA6-D6EE-84E2-933D16C58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9572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5E1E1B-F5D5-6E9B-8AA2-0BCAB1A718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91D5C9B-BC48-B254-9019-D84C408F71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DB59098-2AF6-A889-639B-1455F3EB54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0155C3A-72C4-F39F-B987-39EB0B1D15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0740CAB-3B5D-1EF3-F073-CEFE19EB3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CB57660-7153-F6D5-A05E-E826FA11E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26640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278C97-EC74-A41D-27DF-FC1F2FDAE4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2E63AAA-01C6-F59A-6FF0-D89D2CF82D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A9870AC-E6F3-A617-8D9B-EE9C09ADB0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E871683-4A6D-1269-77FE-035A6EEFD2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A54C48D-1871-4B69-976D-BD9D47336A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369CB89-562F-44F4-A870-515AE8E68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93880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01E311C-525F-F3DB-4DD2-E82241959B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D1F758E-B454-AF5B-CD23-1C347C251E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757188-882A-6CC5-A24F-9AA57F50F3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FDCBCC-9DCA-401A-8CA3-2AE7F2D59616}" type="datetimeFigureOut">
              <a:rPr kumimoji="1" lang="ja-JP" altLang="en-US" smtClean="0"/>
              <a:t>2024/8/1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D818BC0-39AC-CCEA-19E5-F66F3BCE6C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63663C9-FCA1-0FF5-D118-5576D8D6E1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0762B-12AC-4460-A081-3C2812B005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7669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4">
            <a:extLst>
              <a:ext uri="{FF2B5EF4-FFF2-40B4-BE49-F238E27FC236}">
                <a16:creationId xmlns:a16="http://schemas.microsoft.com/office/drawing/2014/main" id="{B919BFA6-9298-D019-C0CB-ADB6FDB37A0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860675" y="720725"/>
            <a:ext cx="6503990" cy="6100763"/>
            <a:chOff x="1802" y="454"/>
            <a:chExt cx="4097" cy="3843"/>
          </a:xfrm>
        </p:grpSpPr>
        <p:sp>
          <p:nvSpPr>
            <p:cNvPr id="8" name="Line 5">
              <a:extLst>
                <a:ext uri="{FF2B5EF4-FFF2-40B4-BE49-F238E27FC236}">
                  <a16:creationId xmlns:a16="http://schemas.microsoft.com/office/drawing/2014/main" id="{864E9EA1-3EB1-FDD1-6206-51A266BEE5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4" y="3280"/>
              <a:ext cx="2972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284D8AF6-EBF2-8A20-CB2D-14AC4674253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64" y="3280"/>
              <a:ext cx="0" cy="65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" name="Line 7">
              <a:extLst>
                <a:ext uri="{FF2B5EF4-FFF2-40B4-BE49-F238E27FC236}">
                  <a16:creationId xmlns:a16="http://schemas.microsoft.com/office/drawing/2014/main" id="{FFF679EF-E391-DEB0-C52A-30D391329B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66" y="3280"/>
              <a:ext cx="0" cy="65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" name="Line 8">
              <a:extLst>
                <a:ext uri="{FF2B5EF4-FFF2-40B4-BE49-F238E27FC236}">
                  <a16:creationId xmlns:a16="http://schemas.microsoft.com/office/drawing/2014/main" id="{602F29FC-79CF-F0F7-CD7F-8273E8BFC8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60" y="3280"/>
              <a:ext cx="0" cy="65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2" name="Line 9">
              <a:extLst>
                <a:ext uri="{FF2B5EF4-FFF2-40B4-BE49-F238E27FC236}">
                  <a16:creationId xmlns:a16="http://schemas.microsoft.com/office/drawing/2014/main" id="{EC8E0259-9AA5-4FB8-CB6B-A062E81B51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54" y="3280"/>
              <a:ext cx="0" cy="65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3" name="Line 10">
              <a:extLst>
                <a:ext uri="{FF2B5EF4-FFF2-40B4-BE49-F238E27FC236}">
                  <a16:creationId xmlns:a16="http://schemas.microsoft.com/office/drawing/2014/main" id="{4D0DC557-FA20-20A3-605B-FA8B2AAFB7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48" y="3280"/>
              <a:ext cx="0" cy="65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4" name="Line 11">
              <a:extLst>
                <a:ext uri="{FF2B5EF4-FFF2-40B4-BE49-F238E27FC236}">
                  <a16:creationId xmlns:a16="http://schemas.microsoft.com/office/drawing/2014/main" id="{73AE667F-958D-2237-4B2E-30B94E360A5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42" y="3280"/>
              <a:ext cx="0" cy="65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5" name="Line 12">
              <a:extLst>
                <a:ext uri="{FF2B5EF4-FFF2-40B4-BE49-F238E27FC236}">
                  <a16:creationId xmlns:a16="http://schemas.microsoft.com/office/drawing/2014/main" id="{E1EB0C1E-C660-618E-DB8F-341D0E96053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36" y="3280"/>
              <a:ext cx="0" cy="65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A88E9F9B-D19D-6C20-B038-DBFC2251A7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2" y="3432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01E05959-3F0C-C248-755E-70727E4059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8" y="3432"/>
              <a:ext cx="196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0B824040-C017-FE30-A2EC-19545B79FD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9" y="3432"/>
              <a:ext cx="262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7B76D522-B908-1428-36E3-5893E89567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3" y="3432"/>
              <a:ext cx="262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202CE5D2-5F58-62AB-0EFF-B702D04E9E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17" y="3432"/>
              <a:ext cx="262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FD60F310-18E3-5545-CB20-25DF5E3F17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1" y="3432"/>
              <a:ext cx="262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53EB9964-1FEA-BF4E-D3AE-BF5D3511A3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" y="3432"/>
              <a:ext cx="262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Line 20">
              <a:extLst>
                <a:ext uri="{FF2B5EF4-FFF2-40B4-BE49-F238E27FC236}">
                  <a16:creationId xmlns:a16="http://schemas.microsoft.com/office/drawing/2014/main" id="{E366BD6A-CC7F-EF0B-21BE-84C70A857F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48" y="563"/>
              <a:ext cx="0" cy="2608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4" name="Line 21">
              <a:extLst>
                <a:ext uri="{FF2B5EF4-FFF2-40B4-BE49-F238E27FC236}">
                  <a16:creationId xmlns:a16="http://schemas.microsoft.com/office/drawing/2014/main" id="{B0C35A54-6A6B-CD77-B1FB-F43B71193C8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5" y="3171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5" name="Line 22">
              <a:extLst>
                <a:ext uri="{FF2B5EF4-FFF2-40B4-BE49-F238E27FC236}">
                  <a16:creationId xmlns:a16="http://schemas.microsoft.com/office/drawing/2014/main" id="{50A18174-8E21-E993-0669-B5844308C65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5" y="2648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6" name="Line 23">
              <a:extLst>
                <a:ext uri="{FF2B5EF4-FFF2-40B4-BE49-F238E27FC236}">
                  <a16:creationId xmlns:a16="http://schemas.microsoft.com/office/drawing/2014/main" id="{73FBE16D-05C5-0054-F0D5-EF01390166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5" y="2125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7" name="Line 24">
              <a:extLst>
                <a:ext uri="{FF2B5EF4-FFF2-40B4-BE49-F238E27FC236}">
                  <a16:creationId xmlns:a16="http://schemas.microsoft.com/office/drawing/2014/main" id="{09E5E2FF-5A17-4568-B35A-80D262ADC3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5" y="1602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Line 25">
              <a:extLst>
                <a:ext uri="{FF2B5EF4-FFF2-40B4-BE49-F238E27FC236}">
                  <a16:creationId xmlns:a16="http://schemas.microsoft.com/office/drawing/2014/main" id="{D99D0CCB-FAB0-F023-50B8-A1A165301C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5" y="1086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Line 26">
              <a:extLst>
                <a:ext uri="{FF2B5EF4-FFF2-40B4-BE49-F238E27FC236}">
                  <a16:creationId xmlns:a16="http://schemas.microsoft.com/office/drawing/2014/main" id="{61AE44F0-D586-687A-3CA8-105472AE8B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75" y="563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314336C9-9743-FEBB-E174-AFDC59FC33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0" y="3127"/>
              <a:ext cx="134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 </a:t>
              </a:r>
              <a:r>
                <a:rPr kumimoji="0" lang="ja-JP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D85F00D4-21DA-2C8B-A66D-EAE6E45DDB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0" y="2604"/>
              <a:ext cx="169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ja-JP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r>
                <a:rPr kumimoji="0" lang="en-US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D1794583-2D31-6881-C4A1-1A3C6FB054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0" y="2081"/>
              <a:ext cx="169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ja-JP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r>
                <a:rPr kumimoji="0" lang="en-US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0F0ABA8A-8504-EACB-2624-2281B673C5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0" y="1558"/>
              <a:ext cx="169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500" dirty="0">
                  <a:solidFill>
                    <a:srgbClr val="000000"/>
                  </a:solidFill>
                </a:rPr>
                <a:t> 6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DDB23F5D-3307-015A-8F31-856FC048A6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0" y="1035"/>
              <a:ext cx="169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r>
                <a:rPr kumimoji="0" lang="ja-JP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r>
                <a:rPr kumimoji="0" lang="en-US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C6D1304F-43DA-F58B-12BA-EAA548B666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0" y="512"/>
              <a:ext cx="203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r>
                <a:rPr kumimoji="0" lang="en-US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Freeform 33">
              <a:extLst>
                <a:ext uri="{FF2B5EF4-FFF2-40B4-BE49-F238E27FC236}">
                  <a16:creationId xmlns:a16="http://schemas.microsoft.com/office/drawing/2014/main" id="{C81674D0-1762-EE07-CE1A-D2C37B8FA2B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48" y="454"/>
              <a:ext cx="3306" cy="2826"/>
            </a:xfrm>
            <a:custGeom>
              <a:avLst/>
              <a:gdLst>
                <a:gd name="T0" fmla="*/ 0 w 455"/>
                <a:gd name="T1" fmla="*/ 0 h 389"/>
                <a:gd name="T2" fmla="*/ 0 w 455"/>
                <a:gd name="T3" fmla="*/ 389 h 389"/>
                <a:gd name="T4" fmla="*/ 455 w 455"/>
                <a:gd name="T5" fmla="*/ 389 h 3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5" h="389">
                  <a:moveTo>
                    <a:pt x="0" y="0"/>
                  </a:moveTo>
                  <a:lnTo>
                    <a:pt x="0" y="389"/>
                  </a:lnTo>
                  <a:lnTo>
                    <a:pt x="455" y="389"/>
                  </a:lnTo>
                </a:path>
              </a:pathLst>
            </a:cu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8819273D-D5D3-78E1-A6CC-89378FCCA2A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480" y="1790"/>
              <a:ext cx="790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robability</a:t>
              </a:r>
              <a:r>
                <a:rPr kumimoji="0" lang="ja-JP" altLang="en-US" sz="1500" dirty="0">
                  <a:solidFill>
                    <a:srgbClr val="000000"/>
                  </a:solidFill>
                </a:rPr>
                <a:t> </a:t>
              </a:r>
              <a:r>
                <a:rPr kumimoji="0" lang="en-US" altLang="ja-JP" sz="1500" dirty="0">
                  <a:solidFill>
                    <a:srgbClr val="000000"/>
                  </a:solidFill>
                </a:rPr>
                <a:t>(%)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Freeform 36">
              <a:extLst>
                <a:ext uri="{FF2B5EF4-FFF2-40B4-BE49-F238E27FC236}">
                  <a16:creationId xmlns:a16="http://schemas.microsoft.com/office/drawing/2014/main" id="{241469C9-BB7A-98F7-EEB9-5E7786B64892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4" y="563"/>
              <a:ext cx="3067" cy="1634"/>
            </a:xfrm>
            <a:custGeom>
              <a:avLst/>
              <a:gdLst>
                <a:gd name="T0" fmla="*/ 0 w 422"/>
                <a:gd name="T1" fmla="*/ 0 h 225"/>
                <a:gd name="T2" fmla="*/ 59 w 422"/>
                <a:gd name="T3" fmla="*/ 0 h 225"/>
                <a:gd name="T4" fmla="*/ 59 w 422"/>
                <a:gd name="T5" fmla="*/ 17 h 225"/>
                <a:gd name="T6" fmla="*/ 77 w 422"/>
                <a:gd name="T7" fmla="*/ 17 h 225"/>
                <a:gd name="T8" fmla="*/ 77 w 422"/>
                <a:gd name="T9" fmla="*/ 34 h 225"/>
                <a:gd name="T10" fmla="*/ 85 w 422"/>
                <a:gd name="T11" fmla="*/ 34 h 225"/>
                <a:gd name="T12" fmla="*/ 85 w 422"/>
                <a:gd name="T13" fmla="*/ 51 h 225"/>
                <a:gd name="T14" fmla="*/ 101 w 422"/>
                <a:gd name="T15" fmla="*/ 51 h 225"/>
                <a:gd name="T16" fmla="*/ 101 w 422"/>
                <a:gd name="T17" fmla="*/ 69 h 225"/>
                <a:gd name="T18" fmla="*/ 115 w 422"/>
                <a:gd name="T19" fmla="*/ 69 h 225"/>
                <a:gd name="T20" fmla="*/ 115 w 422"/>
                <a:gd name="T21" fmla="*/ 90 h 225"/>
                <a:gd name="T22" fmla="*/ 154 w 422"/>
                <a:gd name="T23" fmla="*/ 90 h 225"/>
                <a:gd name="T24" fmla="*/ 154 w 422"/>
                <a:gd name="T25" fmla="*/ 112 h 225"/>
                <a:gd name="T26" fmla="*/ 172 w 422"/>
                <a:gd name="T27" fmla="*/ 112 h 225"/>
                <a:gd name="T28" fmla="*/ 172 w 422"/>
                <a:gd name="T29" fmla="*/ 135 h 225"/>
                <a:gd name="T30" fmla="*/ 187 w 422"/>
                <a:gd name="T31" fmla="*/ 135 h 225"/>
                <a:gd name="T32" fmla="*/ 187 w 422"/>
                <a:gd name="T33" fmla="*/ 157 h 225"/>
                <a:gd name="T34" fmla="*/ 279 w 422"/>
                <a:gd name="T35" fmla="*/ 157 h 225"/>
                <a:gd name="T36" fmla="*/ 279 w 422"/>
                <a:gd name="T37" fmla="*/ 191 h 225"/>
                <a:gd name="T38" fmla="*/ 316 w 422"/>
                <a:gd name="T39" fmla="*/ 191 h 225"/>
                <a:gd name="T40" fmla="*/ 316 w 422"/>
                <a:gd name="T41" fmla="*/ 225 h 225"/>
                <a:gd name="T42" fmla="*/ 422 w 422"/>
                <a:gd name="T43" fmla="*/ 225 h 2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422" h="225">
                  <a:moveTo>
                    <a:pt x="0" y="0"/>
                  </a:moveTo>
                  <a:lnTo>
                    <a:pt x="59" y="0"/>
                  </a:lnTo>
                  <a:lnTo>
                    <a:pt x="59" y="17"/>
                  </a:lnTo>
                  <a:lnTo>
                    <a:pt x="77" y="17"/>
                  </a:lnTo>
                  <a:lnTo>
                    <a:pt x="77" y="34"/>
                  </a:lnTo>
                  <a:lnTo>
                    <a:pt x="85" y="34"/>
                  </a:lnTo>
                  <a:lnTo>
                    <a:pt x="85" y="51"/>
                  </a:lnTo>
                  <a:lnTo>
                    <a:pt x="101" y="51"/>
                  </a:lnTo>
                  <a:lnTo>
                    <a:pt x="101" y="69"/>
                  </a:lnTo>
                  <a:lnTo>
                    <a:pt x="115" y="69"/>
                  </a:lnTo>
                  <a:lnTo>
                    <a:pt x="115" y="90"/>
                  </a:lnTo>
                  <a:lnTo>
                    <a:pt x="154" y="90"/>
                  </a:lnTo>
                  <a:lnTo>
                    <a:pt x="154" y="112"/>
                  </a:lnTo>
                  <a:lnTo>
                    <a:pt x="172" y="112"/>
                  </a:lnTo>
                  <a:lnTo>
                    <a:pt x="172" y="135"/>
                  </a:lnTo>
                  <a:lnTo>
                    <a:pt x="187" y="135"/>
                  </a:lnTo>
                  <a:lnTo>
                    <a:pt x="187" y="157"/>
                  </a:lnTo>
                  <a:lnTo>
                    <a:pt x="279" y="157"/>
                  </a:lnTo>
                  <a:lnTo>
                    <a:pt x="279" y="191"/>
                  </a:lnTo>
                  <a:lnTo>
                    <a:pt x="316" y="191"/>
                  </a:lnTo>
                  <a:lnTo>
                    <a:pt x="316" y="225"/>
                  </a:lnTo>
                  <a:lnTo>
                    <a:pt x="422" y="225"/>
                  </a:lnTo>
                </a:path>
              </a:pathLst>
            </a:cu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0" name="Line 37">
              <a:extLst>
                <a:ext uri="{FF2B5EF4-FFF2-40B4-BE49-F238E27FC236}">
                  <a16:creationId xmlns:a16="http://schemas.microsoft.com/office/drawing/2014/main" id="{3D068C7C-A037-7EB7-0BE2-5A993EE3B0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6" y="933"/>
              <a:ext cx="72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1" name="Line 38">
              <a:extLst>
                <a:ext uri="{FF2B5EF4-FFF2-40B4-BE49-F238E27FC236}">
                  <a16:creationId xmlns:a16="http://schemas.microsoft.com/office/drawing/2014/main" id="{CD583643-6A90-EFEE-E5DC-6B51EF44C4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62" y="897"/>
              <a:ext cx="0" cy="73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2" name="Line 39">
              <a:extLst>
                <a:ext uri="{FF2B5EF4-FFF2-40B4-BE49-F238E27FC236}">
                  <a16:creationId xmlns:a16="http://schemas.microsoft.com/office/drawing/2014/main" id="{BE9877A4-4CCE-87CC-BE1A-689F320AED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06" y="1064"/>
              <a:ext cx="72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3" name="Line 40">
              <a:extLst>
                <a:ext uri="{FF2B5EF4-FFF2-40B4-BE49-F238E27FC236}">
                  <a16:creationId xmlns:a16="http://schemas.microsoft.com/office/drawing/2014/main" id="{11B60F60-D74D-113E-22C5-30B371BAF1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42" y="1028"/>
              <a:ext cx="0" cy="72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4" name="Line 41">
              <a:extLst>
                <a:ext uri="{FF2B5EF4-FFF2-40B4-BE49-F238E27FC236}">
                  <a16:creationId xmlns:a16="http://schemas.microsoft.com/office/drawing/2014/main" id="{D7BCE514-5C18-7F84-554F-CDCBAD053F2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49" y="1064"/>
              <a:ext cx="80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5" name="Line 42">
              <a:extLst>
                <a:ext uri="{FF2B5EF4-FFF2-40B4-BE49-F238E27FC236}">
                  <a16:creationId xmlns:a16="http://schemas.microsoft.com/office/drawing/2014/main" id="{F9067E8F-168B-7D94-956D-C842BF4203A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85" y="1028"/>
              <a:ext cx="0" cy="72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6" name="Line 43">
              <a:extLst>
                <a:ext uri="{FF2B5EF4-FFF2-40B4-BE49-F238E27FC236}">
                  <a16:creationId xmlns:a16="http://schemas.microsoft.com/office/drawing/2014/main" id="{28C96215-9571-EED7-D366-285F8BB7D68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25" y="1217"/>
              <a:ext cx="80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7" name="Line 44">
              <a:extLst>
                <a:ext uri="{FF2B5EF4-FFF2-40B4-BE49-F238E27FC236}">
                  <a16:creationId xmlns:a16="http://schemas.microsoft.com/office/drawing/2014/main" id="{464C6E0A-93EA-3D2E-0617-924D61CB1E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69" y="1180"/>
              <a:ext cx="0" cy="73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8" name="Line 45">
              <a:extLst>
                <a:ext uri="{FF2B5EF4-FFF2-40B4-BE49-F238E27FC236}">
                  <a16:creationId xmlns:a16="http://schemas.microsoft.com/office/drawing/2014/main" id="{AEF5F972-DEB4-2B0B-159A-A441A1AB87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3" y="1703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49" name="Line 46">
              <a:extLst>
                <a:ext uri="{FF2B5EF4-FFF2-40B4-BE49-F238E27FC236}">
                  <a16:creationId xmlns:a16="http://schemas.microsoft.com/office/drawing/2014/main" id="{50DB1DA1-C382-A25E-6FAD-C757D84248C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60" y="1667"/>
              <a:ext cx="0" cy="73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0" name="Line 47">
              <a:extLst>
                <a:ext uri="{FF2B5EF4-FFF2-40B4-BE49-F238E27FC236}">
                  <a16:creationId xmlns:a16="http://schemas.microsoft.com/office/drawing/2014/main" id="{3BC6A5BE-9735-75F5-4C39-57D5A9F99D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76" y="1703"/>
              <a:ext cx="72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1" name="Line 48">
              <a:extLst>
                <a:ext uri="{FF2B5EF4-FFF2-40B4-BE49-F238E27FC236}">
                  <a16:creationId xmlns:a16="http://schemas.microsoft.com/office/drawing/2014/main" id="{4CC5E1EE-D56A-7714-76AF-5D1BAA4261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12" y="1667"/>
              <a:ext cx="0" cy="73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2" name="Line 49">
              <a:extLst>
                <a:ext uri="{FF2B5EF4-FFF2-40B4-BE49-F238E27FC236}">
                  <a16:creationId xmlns:a16="http://schemas.microsoft.com/office/drawing/2014/main" id="{FEC46DF9-109F-DA02-5A17-D77FEC369C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17" y="1703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3" name="Line 50">
              <a:extLst>
                <a:ext uri="{FF2B5EF4-FFF2-40B4-BE49-F238E27FC236}">
                  <a16:creationId xmlns:a16="http://schemas.microsoft.com/office/drawing/2014/main" id="{9CB905CD-1EF1-37B3-C48E-0594C56AA3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54" y="1667"/>
              <a:ext cx="0" cy="73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4" name="Line 51">
              <a:extLst>
                <a:ext uri="{FF2B5EF4-FFF2-40B4-BE49-F238E27FC236}">
                  <a16:creationId xmlns:a16="http://schemas.microsoft.com/office/drawing/2014/main" id="{FC1FC9D8-4BBC-F791-A54D-33A5D239CC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75" y="2197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5" name="Line 52">
              <a:extLst>
                <a:ext uri="{FF2B5EF4-FFF2-40B4-BE49-F238E27FC236}">
                  <a16:creationId xmlns:a16="http://schemas.microsoft.com/office/drawing/2014/main" id="{FF1226F0-C0FD-7FB1-27FC-426D73E177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11" y="2154"/>
              <a:ext cx="0" cy="8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6" name="Line 53">
              <a:extLst>
                <a:ext uri="{FF2B5EF4-FFF2-40B4-BE49-F238E27FC236}">
                  <a16:creationId xmlns:a16="http://schemas.microsoft.com/office/drawing/2014/main" id="{42066C07-A3D9-5FF0-B945-9EBC2E462C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797" y="2197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7" name="Line 54">
              <a:extLst>
                <a:ext uri="{FF2B5EF4-FFF2-40B4-BE49-F238E27FC236}">
                  <a16:creationId xmlns:a16="http://schemas.microsoft.com/office/drawing/2014/main" id="{C3285D02-EC44-FA18-3407-43ADC03739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833" y="2154"/>
              <a:ext cx="0" cy="8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8" name="Line 55">
              <a:extLst>
                <a:ext uri="{FF2B5EF4-FFF2-40B4-BE49-F238E27FC236}">
                  <a16:creationId xmlns:a16="http://schemas.microsoft.com/office/drawing/2014/main" id="{80674517-4CAD-354D-BA48-AFDAE575BA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51" y="2197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9" name="Line 56">
              <a:extLst>
                <a:ext uri="{FF2B5EF4-FFF2-40B4-BE49-F238E27FC236}">
                  <a16:creationId xmlns:a16="http://schemas.microsoft.com/office/drawing/2014/main" id="{5672C519-C960-746A-846E-85C697F66B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88" y="2154"/>
              <a:ext cx="0" cy="8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0" name="Line 57">
              <a:extLst>
                <a:ext uri="{FF2B5EF4-FFF2-40B4-BE49-F238E27FC236}">
                  <a16:creationId xmlns:a16="http://schemas.microsoft.com/office/drawing/2014/main" id="{045C6C68-3AA2-103D-3046-AAF2A4E39C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94" y="2197"/>
              <a:ext cx="73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1" name="Line 58">
              <a:extLst>
                <a:ext uri="{FF2B5EF4-FFF2-40B4-BE49-F238E27FC236}">
                  <a16:creationId xmlns:a16="http://schemas.microsoft.com/office/drawing/2014/main" id="{22E35AF4-92EF-9D61-DE48-69AF7165E23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31" y="2154"/>
              <a:ext cx="0" cy="8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2" name="Freeform 59">
              <a:extLst>
                <a:ext uri="{FF2B5EF4-FFF2-40B4-BE49-F238E27FC236}">
                  <a16:creationId xmlns:a16="http://schemas.microsoft.com/office/drawing/2014/main" id="{2D63514E-B420-433A-E126-89B013800377}"/>
                </a:ext>
              </a:extLst>
            </p:cNvPr>
            <p:cNvSpPr>
              <a:spLocks/>
            </p:cNvSpPr>
            <p:nvPr/>
          </p:nvSpPr>
          <p:spPr bwMode="auto">
            <a:xfrm>
              <a:off x="2464" y="563"/>
              <a:ext cx="3067" cy="1794"/>
            </a:xfrm>
            <a:custGeom>
              <a:avLst/>
              <a:gdLst>
                <a:gd name="T0" fmla="*/ 0 w 422"/>
                <a:gd name="T1" fmla="*/ 0 h 247"/>
                <a:gd name="T2" fmla="*/ 45 w 422"/>
                <a:gd name="T3" fmla="*/ 0 h 247"/>
                <a:gd name="T4" fmla="*/ 45 w 422"/>
                <a:gd name="T5" fmla="*/ 22 h 247"/>
                <a:gd name="T6" fmla="*/ 66 w 422"/>
                <a:gd name="T7" fmla="*/ 22 h 247"/>
                <a:gd name="T8" fmla="*/ 66 w 422"/>
                <a:gd name="T9" fmla="*/ 45 h 247"/>
                <a:gd name="T10" fmla="*/ 67 w 422"/>
                <a:gd name="T11" fmla="*/ 45 h 247"/>
                <a:gd name="T12" fmla="*/ 67 w 422"/>
                <a:gd name="T13" fmla="*/ 67 h 247"/>
                <a:gd name="T14" fmla="*/ 82 w 422"/>
                <a:gd name="T15" fmla="*/ 67 h 247"/>
                <a:gd name="T16" fmla="*/ 82 w 422"/>
                <a:gd name="T17" fmla="*/ 90 h 247"/>
                <a:gd name="T18" fmla="*/ 96 w 422"/>
                <a:gd name="T19" fmla="*/ 90 h 247"/>
                <a:gd name="T20" fmla="*/ 96 w 422"/>
                <a:gd name="T21" fmla="*/ 134 h 247"/>
                <a:gd name="T22" fmla="*/ 115 w 422"/>
                <a:gd name="T23" fmla="*/ 134 h 247"/>
                <a:gd name="T24" fmla="*/ 115 w 422"/>
                <a:gd name="T25" fmla="*/ 157 h 247"/>
                <a:gd name="T26" fmla="*/ 134 w 422"/>
                <a:gd name="T27" fmla="*/ 157 h 247"/>
                <a:gd name="T28" fmla="*/ 134 w 422"/>
                <a:gd name="T29" fmla="*/ 179 h 247"/>
                <a:gd name="T30" fmla="*/ 162 w 422"/>
                <a:gd name="T31" fmla="*/ 179 h 247"/>
                <a:gd name="T32" fmla="*/ 162 w 422"/>
                <a:gd name="T33" fmla="*/ 202 h 247"/>
                <a:gd name="T34" fmla="*/ 181 w 422"/>
                <a:gd name="T35" fmla="*/ 202 h 247"/>
                <a:gd name="T36" fmla="*/ 181 w 422"/>
                <a:gd name="T37" fmla="*/ 224 h 247"/>
                <a:gd name="T38" fmla="*/ 277 w 422"/>
                <a:gd name="T39" fmla="*/ 224 h 247"/>
                <a:gd name="T40" fmla="*/ 277 w 422"/>
                <a:gd name="T41" fmla="*/ 247 h 247"/>
                <a:gd name="T42" fmla="*/ 422 w 422"/>
                <a:gd name="T43" fmla="*/ 247 h 2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422" h="247">
                  <a:moveTo>
                    <a:pt x="0" y="0"/>
                  </a:moveTo>
                  <a:lnTo>
                    <a:pt x="45" y="0"/>
                  </a:lnTo>
                  <a:lnTo>
                    <a:pt x="45" y="22"/>
                  </a:lnTo>
                  <a:lnTo>
                    <a:pt x="66" y="22"/>
                  </a:lnTo>
                  <a:lnTo>
                    <a:pt x="66" y="45"/>
                  </a:lnTo>
                  <a:lnTo>
                    <a:pt x="67" y="45"/>
                  </a:lnTo>
                  <a:lnTo>
                    <a:pt x="67" y="67"/>
                  </a:lnTo>
                  <a:lnTo>
                    <a:pt x="82" y="67"/>
                  </a:lnTo>
                  <a:lnTo>
                    <a:pt x="82" y="90"/>
                  </a:lnTo>
                  <a:lnTo>
                    <a:pt x="96" y="90"/>
                  </a:lnTo>
                  <a:lnTo>
                    <a:pt x="96" y="134"/>
                  </a:lnTo>
                  <a:lnTo>
                    <a:pt x="115" y="134"/>
                  </a:lnTo>
                  <a:lnTo>
                    <a:pt x="115" y="157"/>
                  </a:lnTo>
                  <a:lnTo>
                    <a:pt x="134" y="157"/>
                  </a:lnTo>
                  <a:lnTo>
                    <a:pt x="134" y="179"/>
                  </a:lnTo>
                  <a:lnTo>
                    <a:pt x="162" y="179"/>
                  </a:lnTo>
                  <a:lnTo>
                    <a:pt x="162" y="202"/>
                  </a:lnTo>
                  <a:lnTo>
                    <a:pt x="181" y="202"/>
                  </a:lnTo>
                  <a:lnTo>
                    <a:pt x="181" y="224"/>
                  </a:lnTo>
                  <a:lnTo>
                    <a:pt x="277" y="224"/>
                  </a:lnTo>
                  <a:lnTo>
                    <a:pt x="277" y="247"/>
                  </a:lnTo>
                  <a:lnTo>
                    <a:pt x="422" y="247"/>
                  </a:lnTo>
                </a:path>
              </a:pathLst>
            </a:cu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3" name="Line 60">
              <a:extLst>
                <a:ext uri="{FF2B5EF4-FFF2-40B4-BE49-F238E27FC236}">
                  <a16:creationId xmlns:a16="http://schemas.microsoft.com/office/drawing/2014/main" id="{2F35D585-DC63-3FB6-8DA7-035FC3B8423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71" y="2357"/>
              <a:ext cx="73" cy="0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Line 61">
              <a:extLst>
                <a:ext uri="{FF2B5EF4-FFF2-40B4-BE49-F238E27FC236}">
                  <a16:creationId xmlns:a16="http://schemas.microsoft.com/office/drawing/2014/main" id="{FEBDA8D9-113F-F7D3-1C87-AC61ED82B7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008" y="2321"/>
              <a:ext cx="0" cy="73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5" name="Line 62">
              <a:extLst>
                <a:ext uri="{FF2B5EF4-FFF2-40B4-BE49-F238E27FC236}">
                  <a16:creationId xmlns:a16="http://schemas.microsoft.com/office/drawing/2014/main" id="{20D92676-A2CA-6E48-7F8B-FC8DFE67FE5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91" y="2357"/>
              <a:ext cx="73" cy="0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6" name="Line 63">
              <a:extLst>
                <a:ext uri="{FF2B5EF4-FFF2-40B4-BE49-F238E27FC236}">
                  <a16:creationId xmlns:a16="http://schemas.microsoft.com/office/drawing/2014/main" id="{8CF2B668-3444-E02C-BEE9-298DBDF038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27" y="2321"/>
              <a:ext cx="0" cy="73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7" name="Line 64">
              <a:extLst>
                <a:ext uri="{FF2B5EF4-FFF2-40B4-BE49-F238E27FC236}">
                  <a16:creationId xmlns:a16="http://schemas.microsoft.com/office/drawing/2014/main" id="{DA8837D3-89A2-CCEA-F6BB-2214AFA868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29" y="2357"/>
              <a:ext cx="73" cy="0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8" name="Line 65">
              <a:extLst>
                <a:ext uri="{FF2B5EF4-FFF2-40B4-BE49-F238E27FC236}">
                  <a16:creationId xmlns:a16="http://schemas.microsoft.com/office/drawing/2014/main" id="{DA87E0A2-4C69-9DCE-3184-A93AE041233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465" y="2321"/>
              <a:ext cx="0" cy="73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9" name="Line 66">
              <a:extLst>
                <a:ext uri="{FF2B5EF4-FFF2-40B4-BE49-F238E27FC236}">
                  <a16:creationId xmlns:a16="http://schemas.microsoft.com/office/drawing/2014/main" id="{BF8C6BA8-FE27-8FBD-7408-316C5A853B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73" y="2357"/>
              <a:ext cx="80" cy="0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0" name="Line 67">
              <a:extLst>
                <a:ext uri="{FF2B5EF4-FFF2-40B4-BE49-F238E27FC236}">
                  <a16:creationId xmlns:a16="http://schemas.microsoft.com/office/drawing/2014/main" id="{BB46C2DB-EE80-693B-DA5E-555B091058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16" y="2321"/>
              <a:ext cx="0" cy="73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1" name="Line 68">
              <a:extLst>
                <a:ext uri="{FF2B5EF4-FFF2-40B4-BE49-F238E27FC236}">
                  <a16:creationId xmlns:a16="http://schemas.microsoft.com/office/drawing/2014/main" id="{C75C99F8-B079-1971-7187-CBAC0AF607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94" y="2357"/>
              <a:ext cx="73" cy="0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2" name="Line 69">
              <a:extLst>
                <a:ext uri="{FF2B5EF4-FFF2-40B4-BE49-F238E27FC236}">
                  <a16:creationId xmlns:a16="http://schemas.microsoft.com/office/drawing/2014/main" id="{B14D0FBD-4504-69CA-6995-6790E2A9F7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531" y="2321"/>
              <a:ext cx="0" cy="73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A409845E-1FC7-10B9-9878-4F64DE9337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6" y="3992"/>
              <a:ext cx="196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0B5C7A63-8888-FAFB-1730-22845857DE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8" y="3992"/>
              <a:ext cx="196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DBC5BC9A-97A1-9DD8-88B4-6EC2522E11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2" y="3992"/>
              <a:ext cx="196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73">
              <a:extLst>
                <a:ext uri="{FF2B5EF4-FFF2-40B4-BE49-F238E27FC236}">
                  <a16:creationId xmlns:a16="http://schemas.microsoft.com/office/drawing/2014/main" id="{25768570-3AE7-91F2-CBBF-83518D120E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2" y="3992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4">
              <a:extLst>
                <a:ext uri="{FF2B5EF4-FFF2-40B4-BE49-F238E27FC236}">
                  <a16:creationId xmlns:a16="http://schemas.microsoft.com/office/drawing/2014/main" id="{7B371068-C3A6-CAF3-2A2B-1BACF2FD32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6" y="3992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30802DB6-B39E-B35E-4FBB-0B48CCCC16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0" y="3992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76">
              <a:extLst>
                <a:ext uri="{FF2B5EF4-FFF2-40B4-BE49-F238E27FC236}">
                  <a16:creationId xmlns:a16="http://schemas.microsoft.com/office/drawing/2014/main" id="{63FA5F8D-1239-D57D-42BD-2B939CB9D4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4" y="3992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id="{034C9B3D-A1E3-A625-F449-4D9BF11340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6" y="4130"/>
              <a:ext cx="196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65D06C3A-D6F7-635D-0181-F59DFD36D9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68" y="4130"/>
              <a:ext cx="196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E4F173B0-D1F7-B835-F371-AEDC1B1B01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98" y="4130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F98EFA74-9937-3C58-6F9A-8922D30448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2" y="4130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1">
              <a:extLst>
                <a:ext uri="{FF2B5EF4-FFF2-40B4-BE49-F238E27FC236}">
                  <a16:creationId xmlns:a16="http://schemas.microsoft.com/office/drawing/2014/main" id="{A3AF5AA6-17FF-FE9A-417C-F8AC9072A3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6" y="4130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82">
              <a:extLst>
                <a:ext uri="{FF2B5EF4-FFF2-40B4-BE49-F238E27FC236}">
                  <a16:creationId xmlns:a16="http://schemas.microsoft.com/office/drawing/2014/main" id="{572B61BA-91E8-FF91-C57E-34F5051D11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0" y="4130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83">
              <a:extLst>
                <a:ext uri="{FF2B5EF4-FFF2-40B4-BE49-F238E27FC236}">
                  <a16:creationId xmlns:a16="http://schemas.microsoft.com/office/drawing/2014/main" id="{22340A35-1C60-BA14-61D4-B7EC82EA91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4" y="4130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84">
              <a:extLst>
                <a:ext uri="{FF2B5EF4-FFF2-40B4-BE49-F238E27FC236}">
                  <a16:creationId xmlns:a16="http://schemas.microsoft.com/office/drawing/2014/main" id="{A36E168D-A351-62BF-9567-47236015C2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5" y="3992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5">
              <a:extLst>
                <a:ext uri="{FF2B5EF4-FFF2-40B4-BE49-F238E27FC236}">
                  <a16:creationId xmlns:a16="http://schemas.microsoft.com/office/drawing/2014/main" id="{B0F4FC0C-A86E-E0D7-1EA0-28FBF8313E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5" y="4130"/>
              <a:ext cx="124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6">
              <a:extLst>
                <a:ext uri="{FF2B5EF4-FFF2-40B4-BE49-F238E27FC236}">
                  <a16:creationId xmlns:a16="http://schemas.microsoft.com/office/drawing/2014/main" id="{E5A6B4A4-E5DE-4954-23D0-377B3142E6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8" y="3781"/>
              <a:ext cx="865" cy="1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5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umber at risk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Line 87">
              <a:extLst>
                <a:ext uri="{FF2B5EF4-FFF2-40B4-BE49-F238E27FC236}">
                  <a16:creationId xmlns:a16="http://schemas.microsoft.com/office/drawing/2014/main" id="{49D2B04E-7878-747E-007D-74F774FDA6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00" y="737"/>
              <a:ext cx="211" cy="0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1" name="Line 88">
              <a:extLst>
                <a:ext uri="{FF2B5EF4-FFF2-40B4-BE49-F238E27FC236}">
                  <a16:creationId xmlns:a16="http://schemas.microsoft.com/office/drawing/2014/main" id="{3A74D9A5-C6D2-D35F-5A26-FD581D41CA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00" y="875"/>
              <a:ext cx="211" cy="0"/>
            </a:xfrm>
            <a:prstGeom prst="line">
              <a:avLst/>
            </a:prstGeom>
            <a:noFill/>
            <a:ln w="11113" cap="rnd">
              <a:solidFill>
                <a:srgbClr val="DF536B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3" name="Rectangle 90">
              <a:extLst>
                <a:ext uri="{FF2B5EF4-FFF2-40B4-BE49-F238E27FC236}">
                  <a16:creationId xmlns:a16="http://schemas.microsoft.com/office/drawing/2014/main" id="{2EBFEDF6-512E-162E-CEC0-8199640107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4" y="654"/>
              <a:ext cx="458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500" dirty="0">
                  <a:solidFill>
                    <a:srgbClr val="000000"/>
                  </a:solidFill>
                </a:rPr>
                <a:t>First line</a:t>
              </a:r>
            </a:p>
          </p:txBody>
        </p:sp>
        <p:sp>
          <p:nvSpPr>
            <p:cNvPr id="94" name="Rectangle 91">
              <a:extLst>
                <a:ext uri="{FF2B5EF4-FFF2-40B4-BE49-F238E27FC236}">
                  <a16:creationId xmlns:a16="http://schemas.microsoft.com/office/drawing/2014/main" id="{DB115429-C3C5-1198-152F-1948DD837D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4" y="792"/>
              <a:ext cx="635" cy="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500" dirty="0">
                  <a:solidFill>
                    <a:srgbClr val="000000"/>
                  </a:solidFill>
                </a:rPr>
                <a:t>Second line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95" name="Rectangle 34">
            <a:extLst>
              <a:ext uri="{FF2B5EF4-FFF2-40B4-BE49-F238E27FC236}">
                <a16:creationId xmlns:a16="http://schemas.microsoft.com/office/drawing/2014/main" id="{4FCAD58F-AAA7-BF26-D93C-1AF56553D8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53051" y="5688013"/>
            <a:ext cx="202723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6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  <a:t>Follow up period (day)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204EF56-D119-539E-E2B2-6D020162037E}"/>
              </a:ext>
            </a:extLst>
          </p:cNvPr>
          <p:cNvSpPr txBox="1"/>
          <p:nvPr/>
        </p:nvSpPr>
        <p:spPr>
          <a:xfrm>
            <a:off x="84221" y="108284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8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1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321021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2</Words>
  <Application>Microsoft Office PowerPoint</Application>
  <PresentationFormat>ワイド画面</PresentationFormat>
  <Paragraphs>3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哲 友成</dc:creator>
  <cp:lastModifiedBy>哲 友成</cp:lastModifiedBy>
  <cp:revision>3</cp:revision>
  <dcterms:created xsi:type="dcterms:W3CDTF">2024-06-02T01:29:32Z</dcterms:created>
  <dcterms:modified xsi:type="dcterms:W3CDTF">2024-08-14T00:55:51Z</dcterms:modified>
</cp:coreProperties>
</file>